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6858F9-6A56-4FBD-9399-67D7DEF056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3217DA-5AD0-4D2B-B246-2FAD19C91A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2D913C-8975-4BC2-A667-CFE4ABBBE3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284B78-6491-478E-AEAF-7111AC01757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ECDDA1-3296-48A0-8096-BEBC2D1405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6BBC70-594E-4293-8BC3-D31885CEFF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8A3A90-57BA-4198-87ED-EADA79E915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23238B-856C-44E1-860A-93D4BEB25D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4C54A6-5612-4DC0-AC14-F676C520D2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E8194B-DB81-4646-84CD-F03DF7973B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6DCB26-9732-4E47-A02A-3F4870B568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61717E-4208-4ADC-AACF-1F0D22E228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8C9E15-8CBC-495E-A3C6-E64D4BB5B31E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71826D-E077-4597-BA89-BF01725BC66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347760" y="104760"/>
            <a:ext cx="11372760" cy="11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Supplementary FIG 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: Clustal Omega alignment of LolC (A) and LolE (B) showing structural features and mutated residues. Characters above the alignments: V: residues involved in lipoprotein binding (7); *: residues mutated in isolates with reduced susceptibility to SMT-738; +: residues mutated in resistant isolates from Mcleod (19) and Nickerson (10); Annotations below the alignments show: &lt;TM1-4&gt;: Transmembrane domains; &lt;PD&gt;: Periplasmic Domain; &lt;Hook&gt; and ^ (pad) are LolA-interacting residues (11, 7). Protein sequences were predicted based on in-house whole-genome sequencing of the strains. Clustal Omega alignment (22) was performed at https://www.ebi.ac.uk/Tools/common/tools/help/index.html?tool=clustalo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Reference: Sievers F, Wilm A, Dineen D, Gibson TJ, Karplus K, Li W, Lopez R, McWilliam H, Remmert M, Söding J, Thompson JD, Higgins DG. 2011. Fast, scalable generation of high-quality protein multiple sequence alignments using Clustal Omega. Mol Syst Biol 7:539. https://doi.org/10.1038/msb.2011.7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5" descr=""/>
          <p:cNvPicPr/>
          <p:nvPr/>
        </p:nvPicPr>
        <p:blipFill>
          <a:blip r:embed="rId1"/>
          <a:stretch/>
        </p:blipFill>
        <p:spPr>
          <a:xfrm>
            <a:off x="696960" y="1273320"/>
            <a:ext cx="5003640" cy="49212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7" descr=""/>
          <p:cNvPicPr/>
          <p:nvPr/>
        </p:nvPicPr>
        <p:blipFill>
          <a:blip r:embed="rId2"/>
          <a:stretch/>
        </p:blipFill>
        <p:spPr>
          <a:xfrm>
            <a:off x="6994440" y="1273320"/>
            <a:ext cx="4726080" cy="4995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9-18T20:24:00Z</dcterms:created>
  <dc:creator>Chien-Ming Li</dc:creator>
  <dc:description/>
  <dc:language>en-US</dc:language>
  <cp:lastModifiedBy>Vasanthi.M</cp:lastModifiedBy>
  <dcterms:modified xsi:type="dcterms:W3CDTF">2023-11-29T10:15:28Z</dcterms:modified>
  <cp:revision>4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45292DA48A0445D89F05D6782F79D80_12</vt:lpwstr>
  </property>
  <property fmtid="{D5CDD505-2E9C-101B-9397-08002B2CF9AE}" pid="3" name="KSOProductBuildVer">
    <vt:lpwstr>1033-12.2.0.13306</vt:lpwstr>
  </property>
</Properties>
</file>